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1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0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2DB45-E084-4EEB-BDBB-DB7807CB238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920E-D5E4-4C6A-A1A6-FCB506D880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186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2DB45-E084-4EEB-BDBB-DB7807CB238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920E-D5E4-4C6A-A1A6-FCB506D880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0285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2DB45-E084-4EEB-BDBB-DB7807CB238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920E-D5E4-4C6A-A1A6-FCB506D880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2408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2DB45-E084-4EEB-BDBB-DB7807CB238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920E-D5E4-4C6A-A1A6-FCB506D880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9042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2DB45-E084-4EEB-BDBB-DB7807CB238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920E-D5E4-4C6A-A1A6-FCB506D880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59858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2DB45-E084-4EEB-BDBB-DB7807CB238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920E-D5E4-4C6A-A1A6-FCB506D880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5156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2DB45-E084-4EEB-BDBB-DB7807CB238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920E-D5E4-4C6A-A1A6-FCB506D880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7442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2DB45-E084-4EEB-BDBB-DB7807CB238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920E-D5E4-4C6A-A1A6-FCB506D880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83244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2DB45-E084-4EEB-BDBB-DB7807CB238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920E-D5E4-4C6A-A1A6-FCB506D880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3008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2DB45-E084-4EEB-BDBB-DB7807CB238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920E-D5E4-4C6A-A1A6-FCB506D880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29438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2DB45-E084-4EEB-BDBB-DB7807CB238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920E-D5E4-4C6A-A1A6-FCB506D880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2892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02DB45-E084-4EEB-BDBB-DB7807CB238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B5920E-D5E4-4C6A-A1A6-FCB506D8801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1929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41"/>
          <a:stretch/>
        </p:blipFill>
        <p:spPr bwMode="auto">
          <a:xfrm rot="16200000">
            <a:off x="2120602" y="-718437"/>
            <a:ext cx="2584047" cy="4910994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CuadroTexto 4"/>
          <p:cNvSpPr txBox="1"/>
          <p:nvPr/>
        </p:nvSpPr>
        <p:spPr>
          <a:xfrm>
            <a:off x="2259484" y="-45756"/>
            <a:ext cx="18567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smtClean="0"/>
              <a:t>Simple 5p </a:t>
            </a:r>
            <a:r>
              <a:rPr lang="es-ES" sz="1600" b="1" dirty="0" err="1" smtClean="0"/>
              <a:t>deletions</a:t>
            </a:r>
            <a:endParaRPr lang="es-ES" sz="1600" b="1" dirty="0"/>
          </a:p>
        </p:txBody>
      </p:sp>
      <p:pic>
        <p:nvPicPr>
          <p:cNvPr id="6" name="Imagen 5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2102" y="677108"/>
            <a:ext cx="1622315" cy="1341588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8" name="Tabla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4466116"/>
              </p:ext>
            </p:extLst>
          </p:nvPr>
        </p:nvGraphicFramePr>
        <p:xfrm>
          <a:off x="6715771" y="123521"/>
          <a:ext cx="4555067" cy="284609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29267"/>
                <a:gridCol w="905933"/>
                <a:gridCol w="660400"/>
                <a:gridCol w="1659467"/>
              </a:tblGrid>
              <a:tr h="442722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Variable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p-value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dirty="0" err="1" smtClean="0">
                          <a:solidFill>
                            <a:schemeClr val="tx1"/>
                          </a:solidFill>
                        </a:rPr>
                        <a:t>Statistical</a:t>
                      </a:r>
                      <a:r>
                        <a:rPr lang="es-ES" sz="800" baseline="0" dirty="0" smtClean="0">
                          <a:solidFill>
                            <a:schemeClr val="tx1"/>
                          </a:solidFill>
                        </a:rPr>
                        <a:t> test</a:t>
                      </a:r>
                      <a:endParaRPr lang="es-ES" sz="80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Pairs with significant 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</a:rPr>
                        <a:t>differences (P≤0.05)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442722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gestational age at 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</a:rPr>
                        <a:t>birth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</a:rPr>
                        <a:t>0.018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r>
                        <a:rPr lang="es-ES" sz="800" dirty="0" smtClean="0"/>
                        <a:t>ANOVA</a:t>
                      </a:r>
                      <a:endParaRPr lang="es-ES" sz="800" dirty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(</a:t>
                      </a:r>
                      <a:r>
                        <a:rPr lang="en-US" sz="800" dirty="0" smtClean="0">
                          <a:effectLst/>
                        </a:rPr>
                        <a:t>1.3</a:t>
                      </a:r>
                      <a:r>
                        <a:rPr lang="en-US" sz="800" dirty="0">
                          <a:effectLst/>
                        </a:rPr>
                        <a:t>)</a:t>
                      </a:r>
                      <a:endParaRPr lang="es-ES" sz="700" dirty="0">
                        <a:effectLst/>
                      </a:endParaRPr>
                    </a:p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(</a:t>
                      </a:r>
                      <a:r>
                        <a:rPr lang="en-US" sz="800" dirty="0" smtClean="0">
                          <a:effectLst/>
                        </a:rPr>
                        <a:t>3.4</a:t>
                      </a:r>
                      <a:r>
                        <a:rPr lang="en-US" sz="800" dirty="0">
                          <a:effectLst/>
                        </a:rPr>
                        <a:t>)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442722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developmental delay corrected by age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</a:rPr>
                        <a:t>0.033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ANOVA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(</a:t>
                      </a:r>
                      <a:r>
                        <a:rPr lang="en-US" sz="800" dirty="0" smtClean="0">
                          <a:effectLst/>
                        </a:rPr>
                        <a:t>1.3</a:t>
                      </a:r>
                      <a:r>
                        <a:rPr lang="en-US" sz="800" dirty="0">
                          <a:effectLst/>
                        </a:rPr>
                        <a:t>)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306090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</a:rPr>
                        <a:t>GFAP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smtClean="0">
                          <a:effectLst/>
                        </a:rPr>
                        <a:t>0.017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r>
                        <a:rPr lang="es-ES" sz="800" dirty="0" smtClean="0"/>
                        <a:t>ANOVA</a:t>
                      </a:r>
                      <a:endParaRPr lang="es-ES" sz="800" dirty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(</a:t>
                      </a:r>
                      <a:r>
                        <a:rPr lang="en-US" sz="800" dirty="0" smtClean="0">
                          <a:effectLst/>
                        </a:rPr>
                        <a:t>1.3</a:t>
                      </a:r>
                      <a:r>
                        <a:rPr lang="en-US" sz="800" dirty="0">
                          <a:effectLst/>
                        </a:rPr>
                        <a:t>)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31974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epicanthus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</a:rPr>
                        <a:t>0.007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Chi </a:t>
                      </a:r>
                      <a:r>
                        <a:rPr lang="es-ES" sz="800" dirty="0" err="1" smtClean="0"/>
                        <a:t>square</a:t>
                      </a:r>
                      <a:r>
                        <a:rPr lang="es-ES" sz="800" baseline="0" dirty="0" smtClean="0"/>
                        <a:t> </a:t>
                      </a:r>
                      <a:endParaRPr lang="es-ES" sz="800" dirty="0" smtClean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(</a:t>
                      </a:r>
                      <a:r>
                        <a:rPr lang="en-US" sz="800" dirty="0" smtClean="0">
                          <a:effectLst/>
                        </a:rPr>
                        <a:t>1.3</a:t>
                      </a:r>
                      <a:r>
                        <a:rPr lang="en-US" sz="800" dirty="0">
                          <a:effectLst/>
                        </a:rPr>
                        <a:t>)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31974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err="1">
                          <a:solidFill>
                            <a:schemeClr val="tx1"/>
                          </a:solidFill>
                          <a:effectLst/>
                        </a:rPr>
                        <a:t>hypertelorism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smtClean="0">
                          <a:effectLst/>
                        </a:rPr>
                        <a:t>0.019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Chi </a:t>
                      </a:r>
                      <a:r>
                        <a:rPr lang="es-ES" sz="800" dirty="0" err="1" smtClean="0"/>
                        <a:t>square</a:t>
                      </a:r>
                      <a:r>
                        <a:rPr lang="es-ES" sz="800" baseline="0" dirty="0" smtClean="0"/>
                        <a:t> </a:t>
                      </a:r>
                      <a:endParaRPr lang="es-ES" sz="800" dirty="0" smtClean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(</a:t>
                      </a:r>
                      <a:r>
                        <a:rPr lang="en-US" sz="800" dirty="0" smtClean="0">
                          <a:effectLst/>
                        </a:rPr>
                        <a:t>1.4</a:t>
                      </a:r>
                      <a:r>
                        <a:rPr lang="en-US" sz="800" dirty="0">
                          <a:effectLst/>
                        </a:rPr>
                        <a:t>)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31974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severe ID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smtClean="0">
                          <a:effectLst/>
                        </a:rPr>
                        <a:t>0.009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Chi </a:t>
                      </a:r>
                      <a:r>
                        <a:rPr lang="es-ES" sz="800" dirty="0" err="1" smtClean="0"/>
                        <a:t>square</a:t>
                      </a:r>
                      <a:r>
                        <a:rPr lang="es-ES" sz="800" baseline="0" dirty="0" smtClean="0"/>
                        <a:t> </a:t>
                      </a:r>
                      <a:endParaRPr lang="es-ES" sz="800" dirty="0" smtClean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(</a:t>
                      </a:r>
                      <a:r>
                        <a:rPr lang="en-US" sz="800" dirty="0" smtClean="0">
                          <a:effectLst/>
                        </a:rPr>
                        <a:t>1.3</a:t>
                      </a:r>
                      <a:r>
                        <a:rPr lang="en-US" sz="800" dirty="0">
                          <a:effectLst/>
                        </a:rPr>
                        <a:t>)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31974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</a:rPr>
                        <a:t>can read/write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smtClean="0">
                          <a:effectLst/>
                        </a:rPr>
                        <a:t>0.016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Chi </a:t>
                      </a:r>
                      <a:r>
                        <a:rPr lang="es-ES" sz="800" dirty="0" err="1" smtClean="0"/>
                        <a:t>square</a:t>
                      </a:r>
                      <a:r>
                        <a:rPr lang="es-ES" sz="800" baseline="0" dirty="0" smtClean="0"/>
                        <a:t> </a:t>
                      </a:r>
                      <a:endParaRPr lang="es-ES" sz="800" dirty="0" smtClean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(</a:t>
                      </a:r>
                      <a:r>
                        <a:rPr lang="en-US" sz="800" dirty="0" smtClean="0">
                          <a:effectLst/>
                        </a:rPr>
                        <a:t>1.4</a:t>
                      </a:r>
                      <a:r>
                        <a:rPr lang="en-US" sz="800" dirty="0">
                          <a:effectLst/>
                        </a:rPr>
                        <a:t>)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</a:tbl>
          </a:graphicData>
        </a:graphic>
      </p:graphicFrame>
      <p:pic>
        <p:nvPicPr>
          <p:cNvPr id="9" name="Imagen 8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76"/>
          <a:stretch/>
        </p:blipFill>
        <p:spPr bwMode="auto">
          <a:xfrm rot="16200000">
            <a:off x="2189707" y="2408232"/>
            <a:ext cx="2407160" cy="4872316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Imagen 9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03117" y="3761531"/>
            <a:ext cx="1460284" cy="1168401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11" name="Tab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8967810"/>
              </p:ext>
            </p:extLst>
          </p:nvPr>
        </p:nvGraphicFramePr>
        <p:xfrm>
          <a:off x="6804670" y="3151932"/>
          <a:ext cx="4377268" cy="35560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28659"/>
                <a:gridCol w="1128891"/>
                <a:gridCol w="652005"/>
                <a:gridCol w="1567713"/>
              </a:tblGrid>
              <a:tr h="440194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ariable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-value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r>
                        <a:rPr lang="es-ES" sz="800" dirty="0" err="1" smtClean="0">
                          <a:solidFill>
                            <a:schemeClr val="tx1"/>
                          </a:solidFill>
                          <a:latin typeface="+mn-lt"/>
                        </a:rPr>
                        <a:t>Statistical</a:t>
                      </a:r>
                      <a:r>
                        <a:rPr lang="es-ES" sz="800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test</a:t>
                      </a:r>
                      <a:endParaRPr lang="es-ES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irs with significant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ifferences</a:t>
                      </a: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</a:rPr>
                        <a:t>(P≤0.05)</a:t>
                      </a:r>
                      <a:endParaRPr lang="es-ES" sz="700" dirty="0" smtClean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6806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w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ight </a:t>
                      </a: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t birth 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05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ANOVA</a:t>
                      </a:r>
                      <a:endParaRPr lang="es-ES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A.B)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6806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FC at birth 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10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ANOVA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A.B)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76806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03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Chi </a:t>
                      </a:r>
                      <a:r>
                        <a:rPr lang="es-ES" sz="800" dirty="0" err="1" smtClean="0">
                          <a:solidFill>
                            <a:schemeClr val="tx1"/>
                          </a:solidFill>
                          <a:latin typeface="+mn-lt"/>
                        </a:rPr>
                        <a:t>square</a:t>
                      </a:r>
                      <a:r>
                        <a:rPr lang="es-ES" sz="800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</a:t>
                      </a:r>
                      <a:endParaRPr lang="es-ES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A.B)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76806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UGR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35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Chi </a:t>
                      </a:r>
                      <a:r>
                        <a:rPr lang="es-ES" sz="800" dirty="0" err="1" smtClean="0">
                          <a:solidFill>
                            <a:schemeClr val="tx1"/>
                          </a:solidFill>
                          <a:latin typeface="+mn-lt"/>
                        </a:rPr>
                        <a:t>square</a:t>
                      </a:r>
                      <a:r>
                        <a:rPr lang="es-ES" sz="800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</a:t>
                      </a:r>
                      <a:endParaRPr lang="es-ES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A.B)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76806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und </a:t>
                      </a: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ace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35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Chi </a:t>
                      </a:r>
                      <a:r>
                        <a:rPr lang="es-ES" sz="800" dirty="0" err="1" smtClean="0">
                          <a:solidFill>
                            <a:schemeClr val="tx1"/>
                          </a:solidFill>
                          <a:latin typeface="+mn-lt"/>
                        </a:rPr>
                        <a:t>square</a:t>
                      </a:r>
                      <a:r>
                        <a:rPr lang="es-ES" sz="800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</a:t>
                      </a:r>
                      <a:endParaRPr lang="es-ES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A.B)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76806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</a:t>
                      </a:r>
                      <a:r>
                        <a:rPr lang="en-US" sz="8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larged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ace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25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Chi </a:t>
                      </a:r>
                      <a:r>
                        <a:rPr lang="es-ES" sz="800" dirty="0" err="1" smtClean="0">
                          <a:solidFill>
                            <a:schemeClr val="tx1"/>
                          </a:solidFill>
                          <a:latin typeface="+mn-lt"/>
                        </a:rPr>
                        <a:t>square</a:t>
                      </a:r>
                      <a:r>
                        <a:rPr lang="es-ES" sz="800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</a:t>
                      </a:r>
                      <a:endParaRPr lang="es-ES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A.B)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76806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asal defects</a:t>
                      </a:r>
                      <a:endParaRPr lang="es-ES" sz="7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37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Chi </a:t>
                      </a:r>
                      <a:r>
                        <a:rPr lang="es-ES" sz="800" dirty="0" err="1" smtClean="0">
                          <a:solidFill>
                            <a:schemeClr val="tx1"/>
                          </a:solidFill>
                          <a:latin typeface="+mn-lt"/>
                        </a:rPr>
                        <a:t>square</a:t>
                      </a:r>
                      <a:r>
                        <a:rPr lang="es-ES" sz="800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</a:t>
                      </a:r>
                      <a:endParaRPr lang="es-ES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A.B)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76806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icrognathia</a:t>
                      </a:r>
                      <a:endParaRPr lang="es-ES" sz="7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34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Chi </a:t>
                      </a:r>
                      <a:r>
                        <a:rPr lang="es-ES" sz="800" dirty="0" err="1" smtClean="0">
                          <a:solidFill>
                            <a:schemeClr val="tx1"/>
                          </a:solidFill>
                          <a:latin typeface="+mn-lt"/>
                        </a:rPr>
                        <a:t>square</a:t>
                      </a:r>
                      <a:r>
                        <a:rPr lang="es-ES" sz="800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</a:t>
                      </a:r>
                      <a:endParaRPr lang="es-ES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A.B)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76806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reath problems</a:t>
                      </a:r>
                      <a:endParaRPr lang="es-ES" sz="7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35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Chi </a:t>
                      </a:r>
                      <a:r>
                        <a:rPr lang="es-ES" sz="800" dirty="0" err="1" smtClean="0">
                          <a:solidFill>
                            <a:schemeClr val="tx1"/>
                          </a:solidFill>
                          <a:latin typeface="+mn-lt"/>
                        </a:rPr>
                        <a:t>square</a:t>
                      </a:r>
                      <a:r>
                        <a:rPr lang="es-ES" sz="800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</a:t>
                      </a:r>
                      <a:endParaRPr lang="es-ES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A.B)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76806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pinal anomalies</a:t>
                      </a:r>
                      <a:endParaRPr lang="es-ES" sz="7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29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Chi </a:t>
                      </a:r>
                      <a:r>
                        <a:rPr lang="es-ES" sz="800" dirty="0" err="1" smtClean="0">
                          <a:solidFill>
                            <a:schemeClr val="tx1"/>
                          </a:solidFill>
                          <a:latin typeface="+mn-lt"/>
                        </a:rPr>
                        <a:t>square</a:t>
                      </a:r>
                      <a:r>
                        <a:rPr lang="es-ES" sz="800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</a:t>
                      </a:r>
                      <a:endParaRPr lang="es-ES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A.B)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76806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coliosis</a:t>
                      </a:r>
                      <a:endParaRPr lang="es-ES" sz="70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35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Chi </a:t>
                      </a:r>
                      <a:r>
                        <a:rPr lang="es-ES" sz="800" dirty="0" err="1" smtClean="0">
                          <a:solidFill>
                            <a:schemeClr val="tx1"/>
                          </a:solidFill>
                          <a:latin typeface="+mn-lt"/>
                        </a:rPr>
                        <a:t>square</a:t>
                      </a:r>
                      <a:r>
                        <a:rPr lang="es-ES" sz="800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</a:t>
                      </a:r>
                      <a:endParaRPr lang="es-ES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A.B)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76806">
                <a:tc>
                  <a:txBody>
                    <a:bodyPr/>
                    <a:lstStyle/>
                    <a:p>
                      <a:pPr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vere ID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n-US" sz="80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12</a:t>
                      </a:r>
                      <a:endParaRPr lang="es-ES" sz="7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Chi </a:t>
                      </a:r>
                      <a:r>
                        <a:rPr lang="es-ES" sz="800" dirty="0" err="1" smtClean="0">
                          <a:solidFill>
                            <a:schemeClr val="tx1"/>
                          </a:solidFill>
                          <a:latin typeface="+mn-lt"/>
                        </a:rPr>
                        <a:t>square</a:t>
                      </a:r>
                      <a:r>
                        <a:rPr lang="es-ES" sz="800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</a:t>
                      </a:r>
                      <a:endParaRPr lang="es-ES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A.B)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sp>
        <p:nvSpPr>
          <p:cNvPr id="2" name="CuadroTexto 1"/>
          <p:cNvSpPr txBox="1"/>
          <p:nvPr/>
        </p:nvSpPr>
        <p:spPr>
          <a:xfrm>
            <a:off x="87232" y="75705"/>
            <a:ext cx="37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)</a:t>
            </a:r>
            <a:endParaRPr lang="es-ES" b="1" dirty="0"/>
          </a:p>
        </p:txBody>
      </p:sp>
      <p:sp>
        <p:nvSpPr>
          <p:cNvPr id="12" name="CuadroTexto 11"/>
          <p:cNvSpPr txBox="1"/>
          <p:nvPr/>
        </p:nvSpPr>
        <p:spPr>
          <a:xfrm>
            <a:off x="6338745" y="75705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  <a:r>
              <a:rPr lang="es-ES" b="1" dirty="0" smtClean="0"/>
              <a:t>)</a:t>
            </a:r>
            <a:endParaRPr lang="es-ES" b="1" dirty="0"/>
          </a:p>
        </p:txBody>
      </p:sp>
      <p:sp>
        <p:nvSpPr>
          <p:cNvPr id="3" name="CuadroTexto 2"/>
          <p:cNvSpPr txBox="1"/>
          <p:nvPr/>
        </p:nvSpPr>
        <p:spPr>
          <a:xfrm>
            <a:off x="2188526" y="4929932"/>
            <a:ext cx="481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“A”</a:t>
            </a:r>
            <a:endParaRPr lang="es-ES" dirty="0"/>
          </a:p>
        </p:txBody>
      </p:sp>
      <p:sp>
        <p:nvSpPr>
          <p:cNvPr id="13" name="CuadroTexto 12"/>
          <p:cNvSpPr txBox="1"/>
          <p:nvPr/>
        </p:nvSpPr>
        <p:spPr>
          <a:xfrm>
            <a:off x="3535011" y="4929932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“B”</a:t>
            </a:r>
            <a:endParaRPr lang="es-ES" dirty="0"/>
          </a:p>
        </p:txBody>
      </p:sp>
      <p:sp>
        <p:nvSpPr>
          <p:cNvPr id="14" name="CuadroTexto 13"/>
          <p:cNvSpPr txBox="1"/>
          <p:nvPr/>
        </p:nvSpPr>
        <p:spPr>
          <a:xfrm>
            <a:off x="1544321" y="3312998"/>
            <a:ext cx="37438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smtClean="0"/>
              <a:t>5p </a:t>
            </a:r>
            <a:r>
              <a:rPr lang="es-ES" sz="1600" b="1" dirty="0" err="1" smtClean="0"/>
              <a:t>deletions</a:t>
            </a:r>
            <a:r>
              <a:rPr lang="es-ES" sz="1600" b="1" dirty="0" smtClean="0"/>
              <a:t> + </a:t>
            </a:r>
            <a:r>
              <a:rPr lang="es-ES" sz="1600" b="1" dirty="0" err="1" smtClean="0"/>
              <a:t>additional</a:t>
            </a:r>
            <a:r>
              <a:rPr lang="es-ES" sz="1600" b="1" dirty="0" smtClean="0"/>
              <a:t> </a:t>
            </a:r>
            <a:r>
              <a:rPr lang="es-ES" sz="1600" b="1" dirty="0" err="1" smtClean="0"/>
              <a:t>rearrangements</a:t>
            </a:r>
            <a:r>
              <a:rPr lang="es-ES" sz="1600" b="1" dirty="0" smtClean="0"/>
              <a:t> </a:t>
            </a:r>
            <a:endParaRPr lang="es-ES" sz="1600" b="1" dirty="0"/>
          </a:p>
        </p:txBody>
      </p:sp>
      <p:sp>
        <p:nvSpPr>
          <p:cNvPr id="15" name="CuadroTexto 14"/>
          <p:cNvSpPr txBox="1"/>
          <p:nvPr/>
        </p:nvSpPr>
        <p:spPr>
          <a:xfrm>
            <a:off x="6338745" y="3272470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d</a:t>
            </a:r>
            <a:r>
              <a:rPr lang="es-ES" b="1" dirty="0" smtClean="0"/>
              <a:t>)</a:t>
            </a:r>
            <a:endParaRPr lang="es-ES" b="1" dirty="0"/>
          </a:p>
        </p:txBody>
      </p:sp>
      <p:sp>
        <p:nvSpPr>
          <p:cNvPr id="16" name="CuadroTexto 15"/>
          <p:cNvSpPr txBox="1"/>
          <p:nvPr/>
        </p:nvSpPr>
        <p:spPr>
          <a:xfrm>
            <a:off x="113510" y="3295337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  <a:r>
              <a:rPr lang="es-ES" b="1" smtClean="0"/>
              <a:t>)</a:t>
            </a:r>
            <a:endParaRPr lang="es-ES" b="1" dirty="0"/>
          </a:p>
        </p:txBody>
      </p:sp>
      <p:sp>
        <p:nvSpPr>
          <p:cNvPr id="7" name="Rectángulo 6"/>
          <p:cNvSpPr/>
          <p:nvPr/>
        </p:nvSpPr>
        <p:spPr>
          <a:xfrm>
            <a:off x="345287" y="6006450"/>
            <a:ext cx="6096000" cy="738664"/>
          </a:xfrm>
          <a:prstGeom prst="rect">
            <a:avLst/>
          </a:prstGeom>
        </p:spPr>
        <p:txBody>
          <a:bodyPr>
            <a:spAutoFit/>
          </a:bodyPr>
          <a:lstStyle/>
          <a:p>
            <a:pPr marL="90170" algn="just">
              <a:lnSpc>
                <a:spcPct val="150000"/>
              </a:lnSpc>
              <a:spcAft>
                <a:spcPts val="0"/>
              </a:spcAft>
            </a:pPr>
            <a:r>
              <a:rPr lang="en-US" sz="7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4. Supplemental data. </a:t>
            </a:r>
            <a:r>
              <a:rPr lang="en-US" sz="7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ard´s </a:t>
            </a:r>
            <a:r>
              <a:rPr lang="en-US" sz="7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erarchical </a:t>
            </a:r>
            <a:r>
              <a:rPr lang="en-US" sz="7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uster of the simple 5p deletion group (</a:t>
            </a:r>
            <a:r>
              <a:rPr lang="en-US" sz="7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</a:t>
            </a:r>
            <a:r>
              <a:rPr lang="en-US" sz="7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(</a:t>
            </a:r>
            <a:r>
              <a:rPr lang="en-US" sz="7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)</a:t>
            </a:r>
            <a:r>
              <a:rPr lang="en-US" sz="7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5p deletion + additional rearrangements group by size of the deletions. BIC and AIC determined to be grouped by four clusters in a) and two in b). </a:t>
            </a:r>
            <a:r>
              <a:rPr lang="en-US" sz="7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OVA analysis for </a:t>
            </a:r>
            <a:r>
              <a:rPr lang="en-US" sz="7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inous</a:t>
            </a:r>
            <a:r>
              <a:rPr lang="en-US" sz="7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ariables or by Chi square test for </a:t>
            </a:r>
            <a:r>
              <a:rPr lang="en-US" sz="7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tegoric</a:t>
            </a:r>
            <a:r>
              <a:rPr lang="en-US" sz="7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ariables was performed to establish the existence of significant differences between clusters. Further Bonferroni´s and z-test for previous significant variables revealed cluster pairs with significant differences among them, in </a:t>
            </a:r>
            <a:r>
              <a:rPr lang="en-US" sz="7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p deletion group (</a:t>
            </a:r>
            <a:r>
              <a:rPr lang="en-US" sz="7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 </a:t>
            </a:r>
            <a:r>
              <a:rPr lang="en-US" sz="7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(</a:t>
            </a:r>
            <a:r>
              <a:rPr lang="en-US" sz="7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)</a:t>
            </a:r>
            <a:r>
              <a:rPr lang="en-US" sz="7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5p deletion + additional rearrangements group</a:t>
            </a:r>
            <a:r>
              <a:rPr lang="en-US" sz="7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s-ES" sz="7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84581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1</TotalTime>
  <Words>310</Words>
  <Application>Microsoft Office PowerPoint</Application>
  <PresentationFormat>Panorámica</PresentationFormat>
  <Paragraphs>9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lian</dc:creator>
  <cp:lastModifiedBy>Julian</cp:lastModifiedBy>
  <cp:revision>21</cp:revision>
  <dcterms:created xsi:type="dcterms:W3CDTF">2021-03-08T15:37:45Z</dcterms:created>
  <dcterms:modified xsi:type="dcterms:W3CDTF">2021-03-22T21:57:59Z</dcterms:modified>
</cp:coreProperties>
</file>